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164592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0" autoAdjust="0"/>
    <p:restoredTop sz="94660"/>
  </p:normalViewPr>
  <p:slideViewPr>
    <p:cSldViewPr snapToGrid="0" showGuides="1">
      <p:cViewPr varScale="1">
        <p:scale>
          <a:sx n="79" d="100"/>
          <a:sy n="79" d="100"/>
        </p:scale>
        <p:origin x="248" y="5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57400" y="1122363"/>
            <a:ext cx="12344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57400" y="3602038"/>
            <a:ext cx="123444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ACE09-F494-4B01-827B-D7323570AF74}" type="datetimeFigureOut">
              <a:rPr lang="en-US" smtClean="0"/>
              <a:t>11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AB5BE-05FB-4CFB-B3F3-560D95A739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6321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ACE09-F494-4B01-827B-D7323570AF74}" type="datetimeFigureOut">
              <a:rPr lang="en-US" smtClean="0"/>
              <a:t>11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AB5BE-05FB-4CFB-B3F3-560D95A739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39892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778615" y="365125"/>
            <a:ext cx="354901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31570" y="365125"/>
            <a:ext cx="1044130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ACE09-F494-4B01-827B-D7323570AF74}" type="datetimeFigureOut">
              <a:rPr lang="en-US" smtClean="0"/>
              <a:t>11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AB5BE-05FB-4CFB-B3F3-560D95A739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41610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ACE09-F494-4B01-827B-D7323570AF74}" type="datetimeFigureOut">
              <a:rPr lang="en-US" smtClean="0"/>
              <a:t>11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AB5BE-05FB-4CFB-B3F3-560D95A739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27508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22998" y="1709739"/>
            <a:ext cx="1419606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22998" y="4589464"/>
            <a:ext cx="1419606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ACE09-F494-4B01-827B-D7323570AF74}" type="datetimeFigureOut">
              <a:rPr lang="en-US" smtClean="0"/>
              <a:t>11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AB5BE-05FB-4CFB-B3F3-560D95A739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91057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31570" y="1825625"/>
            <a:ext cx="699516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32470" y="1825625"/>
            <a:ext cx="699516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ACE09-F494-4B01-827B-D7323570AF74}" type="datetimeFigureOut">
              <a:rPr lang="en-US" smtClean="0"/>
              <a:t>11/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AB5BE-05FB-4CFB-B3F3-560D95A739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81441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33714" y="365126"/>
            <a:ext cx="1419606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33715" y="1681163"/>
            <a:ext cx="696301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33715" y="2505075"/>
            <a:ext cx="696301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332470" y="1681163"/>
            <a:ext cx="6997304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332470" y="2505075"/>
            <a:ext cx="6997304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ACE09-F494-4B01-827B-D7323570AF74}" type="datetimeFigureOut">
              <a:rPr lang="en-US" smtClean="0"/>
              <a:t>11/2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AB5BE-05FB-4CFB-B3F3-560D95A739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8270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ACE09-F494-4B01-827B-D7323570AF74}" type="datetimeFigureOut">
              <a:rPr lang="en-US" smtClean="0"/>
              <a:t>11/2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AB5BE-05FB-4CFB-B3F3-560D95A739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6881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ACE09-F494-4B01-827B-D7323570AF74}" type="datetimeFigureOut">
              <a:rPr lang="en-US" smtClean="0"/>
              <a:t>11/2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AB5BE-05FB-4CFB-B3F3-560D95A739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48657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33714" y="457200"/>
            <a:ext cx="5308520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97304" y="987426"/>
            <a:ext cx="833247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33714" y="2057400"/>
            <a:ext cx="5308520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ACE09-F494-4B01-827B-D7323570AF74}" type="datetimeFigureOut">
              <a:rPr lang="en-US" smtClean="0"/>
              <a:t>11/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AB5BE-05FB-4CFB-B3F3-560D95A739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64044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33714" y="457200"/>
            <a:ext cx="5308520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97304" y="987426"/>
            <a:ext cx="833247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33714" y="2057400"/>
            <a:ext cx="5308520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ACE09-F494-4B01-827B-D7323570AF74}" type="datetimeFigureOut">
              <a:rPr lang="en-US" smtClean="0"/>
              <a:t>11/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AB5BE-05FB-4CFB-B3F3-560D95A739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40350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31570" y="365126"/>
            <a:ext cx="1419606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31570" y="1825625"/>
            <a:ext cx="1419606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31570" y="6356351"/>
            <a:ext cx="370332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DACE09-F494-4B01-827B-D7323570AF74}" type="datetimeFigureOut">
              <a:rPr lang="en-US" smtClean="0"/>
              <a:t>11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452110" y="6356351"/>
            <a:ext cx="555498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624310" y="6356351"/>
            <a:ext cx="370332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AAB5BE-05FB-4CFB-B3F3-560D95A739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56937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E319A5C-13D9-F40A-9812-F9F6F07BCC1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4271" y="620485"/>
            <a:ext cx="5617029" cy="5617029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9BC25F42-48EB-D919-BCA9-6914820076D6}"/>
              </a:ext>
            </a:extLst>
          </p:cNvPr>
          <p:cNvSpPr txBox="1"/>
          <p:nvPr/>
        </p:nvSpPr>
        <p:spPr>
          <a:xfrm>
            <a:off x="2906486" y="6322565"/>
            <a:ext cx="109891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800" b="1" dirty="0" err="1">
                <a:effectLst/>
                <a:latin typeface="PalatinoLinotype"/>
              </a:rPr>
              <a:t>Supplementary</a:t>
            </a:r>
            <a:r>
              <a:rPr lang="fr-FR" sz="1800" b="1" dirty="0">
                <a:effectLst/>
                <a:latin typeface="PalatinoLinotype"/>
              </a:rPr>
              <a:t> Figure 1</a:t>
            </a:r>
            <a:r>
              <a:rPr lang="fr-FR" sz="1800" dirty="0">
                <a:effectLst/>
                <a:latin typeface="PalatinoLinotype"/>
              </a:rPr>
              <a:t>: Annotation </a:t>
            </a:r>
            <a:r>
              <a:rPr lang="fr-FR" sz="1800" dirty="0" err="1">
                <a:effectLst/>
                <a:latin typeface="PalatinoLinotype"/>
              </a:rPr>
              <a:t>statistics</a:t>
            </a:r>
            <a:r>
              <a:rPr lang="fr-FR" sz="1800" dirty="0">
                <a:effectLst/>
                <a:latin typeface="PalatinoLinotype"/>
              </a:rPr>
              <a:t> of the </a:t>
            </a:r>
            <a:r>
              <a:rPr lang="fr-FR" sz="1800" dirty="0" err="1">
                <a:effectLst/>
                <a:latin typeface="PalatinoLinotype"/>
              </a:rPr>
              <a:t>DEGs</a:t>
            </a:r>
            <a:r>
              <a:rPr lang="fr-FR" sz="1800" dirty="0">
                <a:effectLst/>
                <a:latin typeface="PalatinoLinotype"/>
              </a:rPr>
              <a:t> in </a:t>
            </a:r>
            <a:r>
              <a:rPr lang="fr-FR" sz="1800" i="1" dirty="0">
                <a:effectLst/>
                <a:latin typeface="PalatinoLinotype"/>
              </a:rPr>
              <a:t>C. </a:t>
            </a:r>
            <a:r>
              <a:rPr lang="fr-FR" sz="1800" i="1" dirty="0" err="1">
                <a:effectLst/>
                <a:latin typeface="PalatinoLinotype"/>
              </a:rPr>
              <a:t>ensifolium</a:t>
            </a:r>
            <a:r>
              <a:rPr lang="fr-FR" sz="1800" i="1" dirty="0">
                <a:effectLst/>
                <a:latin typeface="PalatinoLinotype"/>
              </a:rPr>
              <a:t> </a:t>
            </a:r>
            <a:r>
              <a:rPr lang="fr-FR" sz="1800" dirty="0" err="1">
                <a:effectLst/>
                <a:latin typeface="PalatinoLinotype"/>
              </a:rPr>
              <a:t>leaves</a:t>
            </a:r>
            <a:r>
              <a:rPr lang="fr-FR" sz="1800" dirty="0">
                <a:effectLst/>
                <a:latin typeface="PalatinoLinotype"/>
              </a:rPr>
              <a:t> in </a:t>
            </a:r>
            <a:r>
              <a:rPr lang="fr-FR" sz="1800" dirty="0" err="1">
                <a:effectLst/>
                <a:latin typeface="PalatinoLinotype"/>
              </a:rPr>
              <a:t>different</a:t>
            </a:r>
            <a:r>
              <a:rPr lang="fr-FR" sz="1800" dirty="0">
                <a:effectLst/>
                <a:latin typeface="PalatinoLinotype"/>
              </a:rPr>
              <a:t> </a:t>
            </a:r>
            <a:r>
              <a:rPr lang="fr-FR" sz="1800" dirty="0" err="1">
                <a:effectLst/>
                <a:latin typeface="PalatinoLinotype"/>
              </a:rPr>
              <a:t>databases</a:t>
            </a:r>
            <a:r>
              <a:rPr lang="fr-FR" sz="1800" dirty="0">
                <a:effectLst/>
                <a:latin typeface="PalatinoLinotype"/>
              </a:rPr>
              <a:t> </a:t>
            </a:r>
            <a:endParaRPr lang="fr-FR" dirty="0"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37758832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</TotalTime>
  <Words>17</Words>
  <Application>Microsoft Macintosh PowerPoint</Application>
  <PresentationFormat>Personnalisé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Linotype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 Nawaz</dc:creator>
  <cp:lastModifiedBy>office</cp:lastModifiedBy>
  <cp:revision>3</cp:revision>
  <dcterms:created xsi:type="dcterms:W3CDTF">2022-08-12T20:54:01Z</dcterms:created>
  <dcterms:modified xsi:type="dcterms:W3CDTF">2022-11-02T17:38:02Z</dcterms:modified>
</cp:coreProperties>
</file>